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83" d="100"/>
          <a:sy n="83" d="100"/>
        </p:scale>
        <p:origin x="54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2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2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74546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9329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2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2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2243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190531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52734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F14BA06-560F-4272-BD1D-D3D251BC0A82}" type="datetimeFigureOut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9/08/2025</a:t>
            </a:fld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22DF36B-8F18-4F81-92A8-26E2BC629512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33973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lvl="0" algn="l">
              <a:defRPr/>
            </a:pPr>
            <a:r>
              <a:rPr lang="en-US" sz="2800" b="1" dirty="0">
                <a:solidFill>
                  <a:prstClr val="white"/>
                </a:solidFill>
              </a:rPr>
              <a:t>Major contributors to musculoskeletal pain among children receiving hemodialysis</a:t>
            </a:r>
            <a:endParaRPr kumimoji="0" lang="en-GB" sz="2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IM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</a:t>
            </a:r>
            <a:r>
              <a:rPr lang="en-US" dirty="0">
                <a:solidFill>
                  <a:prstClr val="white"/>
                </a:solidFill>
              </a:rPr>
              <a:t>xplore the contributors to MSK pain in children receiving hemodialysis 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SIGN &amp; OUTCOME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 Light" panose="020F0302020204030204"/>
                <a:ea typeface="+mn-ea"/>
                <a:cs typeface="+mn-cs"/>
              </a:rPr>
              <a:t>Mosa et al. 2025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n-ea"/>
              <a:cs typeface="+mn-cs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CLUSIO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volvement of MSK is a common morbidity in children with hemodialysis. Calcium × phosphate product and vitamin D level were the most significant factors associated with MSK pai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764" y="2534308"/>
            <a:ext cx="512108" cy="104860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888" y="2509554"/>
            <a:ext cx="512108" cy="118579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888" y="3379298"/>
            <a:ext cx="512108" cy="104860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9764" y="3372224"/>
            <a:ext cx="512108" cy="1048603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2486631" y="2562094"/>
            <a:ext cx="2549619" cy="2343351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Patient demographics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Clinical findings: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MSK exam,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physical function, and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quality of life assessment parameters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Laboratory data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DEXA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1724628" y="3582909"/>
            <a:ext cx="682906" cy="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127235" y="2191037"/>
            <a:ext cx="383130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32 children undergoing hemodialysis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5707960" y="2634354"/>
            <a:ext cx="2255422" cy="41301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roup A: with MSK pain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5658600" y="4268188"/>
            <a:ext cx="2304782" cy="427747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srgbClr val="AA0065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603667" y="4328453"/>
            <a:ext cx="246400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roup B: without MSK pain 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 flipV="1">
            <a:off x="5044763" y="2874551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5017297" y="4060577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8176856" y="1685397"/>
          <a:ext cx="3867090" cy="3812578"/>
        </p:xfrm>
        <a:graphic>
          <a:graphicData uri="http://schemas.openxmlformats.org/drawingml/2006/table">
            <a:tbl>
              <a:tblPr firstRow="1" firstCol="1" bandRow="1"/>
              <a:tblGrid>
                <a:gridCol w="1270598">
                  <a:extLst>
                    <a:ext uri="{9D8B030D-6E8A-4147-A177-3AD203B41FA5}">
                      <a16:colId xmlns:a16="http://schemas.microsoft.com/office/drawing/2014/main" val="3108209280"/>
                    </a:ext>
                  </a:extLst>
                </a:gridCol>
                <a:gridCol w="1298246">
                  <a:extLst>
                    <a:ext uri="{9D8B030D-6E8A-4147-A177-3AD203B41FA5}">
                      <a16:colId xmlns:a16="http://schemas.microsoft.com/office/drawing/2014/main" val="2518910166"/>
                    </a:ext>
                  </a:extLst>
                </a:gridCol>
                <a:gridCol w="1298246">
                  <a:extLst>
                    <a:ext uri="{9D8B030D-6E8A-4147-A177-3AD203B41FA5}">
                      <a16:colId xmlns:a16="http://schemas.microsoft.com/office/drawing/2014/main" val="2861725087"/>
                    </a:ext>
                  </a:extLst>
                </a:gridCol>
              </a:tblGrid>
              <a:tr h="289278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5B9B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5B9B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b="1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nivariate Regression analysi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5B9B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5B9B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9516992"/>
                  </a:ext>
                </a:extLst>
              </a:tr>
              <a:tr h="28927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5B9B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R (95% CI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5B9B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2083148"/>
                  </a:ext>
                </a:extLst>
              </a:tr>
              <a:tr h="66534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alysis duration in year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2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57 (1.2-5.3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8782081"/>
                  </a:ext>
                </a:extLst>
              </a:tr>
              <a:tr h="28927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orbidity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8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8 (0.93-24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5026805"/>
                  </a:ext>
                </a:extLst>
              </a:tr>
              <a:tr h="28927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-HAQ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45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3 (0.11-0.97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2252910"/>
                  </a:ext>
                </a:extLst>
              </a:tr>
              <a:tr h="28927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ds Q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3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9 (0.11-0.77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2104797"/>
                  </a:ext>
                </a:extLst>
              </a:tr>
              <a:tr h="28927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B leve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5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1 (0.39-0.91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7669426"/>
                  </a:ext>
                </a:extLst>
              </a:tr>
              <a:tr h="28927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 X P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4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5 (0.92-0.99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3648087"/>
                  </a:ext>
                </a:extLst>
              </a:tr>
              <a:tr h="578556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itamin D  (ng/l)                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1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1 </a:t>
                      </a: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0.72-0.91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9172882"/>
                  </a:ext>
                </a:extLst>
              </a:tr>
              <a:tr h="28927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erum uric aci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4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99 (1.8-2.1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2918470"/>
                  </a:ext>
                </a:extLst>
              </a:tr>
              <a:tr h="25445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XA (Z-sco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2*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22 (0.06-0.71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CC2E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97914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822125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91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Bob Thompson</cp:lastModifiedBy>
  <cp:revision>4</cp:revision>
  <dcterms:created xsi:type="dcterms:W3CDTF">2025-08-08T20:42:55Z</dcterms:created>
  <dcterms:modified xsi:type="dcterms:W3CDTF">2025-08-29T19:42:51Z</dcterms:modified>
</cp:coreProperties>
</file>